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mp" ContentType="image/png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003"/>
    <p:restoredTop sz="94662"/>
  </p:normalViewPr>
  <p:slideViewPr>
    <p:cSldViewPr snapToGrid="0">
      <p:cViewPr varScale="1">
        <p:scale>
          <a:sx n="153" d="100"/>
          <a:sy n="153" d="100"/>
        </p:scale>
        <p:origin x="80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b="1"/>
              <a:t>FQS5276 CLON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7579974760046774"/>
          <c:y val="0.204801660524627"/>
          <c:w val="0.73298487181619254"/>
          <c:h val="0.52309525755696962"/>
        </c:manualLayout>
      </c:layout>
      <c:lineChart>
        <c:grouping val="standard"/>
        <c:varyColors val="0"/>
        <c:ser>
          <c:idx val="0"/>
          <c:order val="0"/>
          <c:tx>
            <c:strRef>
              <c:f>'SN Ratio tumors'!$T$2</c:f>
              <c:strCache>
                <c:ptCount val="1"/>
                <c:pt idx="0">
                  <c:v>Signal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'SN Ratio tumors'!$U$1:$Y$1</c:f>
              <c:strCache>
                <c:ptCount val="5"/>
                <c:pt idx="0">
                  <c:v>10ug/ml</c:v>
                </c:pt>
                <c:pt idx="1">
                  <c:v>4ug/ml</c:v>
                </c:pt>
                <c:pt idx="2">
                  <c:v>2ug/ml</c:v>
                </c:pt>
                <c:pt idx="3">
                  <c:v>1ug/ml</c:v>
                </c:pt>
                <c:pt idx="4">
                  <c:v>0.4ug/ml</c:v>
                </c:pt>
              </c:strCache>
            </c:strRef>
          </c:cat>
          <c:val>
            <c:numRef>
              <c:f>'SN Ratio tumors'!$U$2:$Y$2</c:f>
              <c:numCache>
                <c:formatCode>General</c:formatCode>
                <c:ptCount val="5"/>
                <c:pt idx="0">
                  <c:v>7899.3345000000008</c:v>
                </c:pt>
                <c:pt idx="1">
                  <c:v>7343.9840000000004</c:v>
                </c:pt>
                <c:pt idx="2">
                  <c:v>7135.0592500000002</c:v>
                </c:pt>
                <c:pt idx="3">
                  <c:v>5937.63825</c:v>
                </c:pt>
                <c:pt idx="4">
                  <c:v>3876.85224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D2F-8D48-868E-3F9324BFE467}"/>
            </c:ext>
          </c:extLst>
        </c:ser>
        <c:ser>
          <c:idx val="1"/>
          <c:order val="1"/>
          <c:tx>
            <c:strRef>
              <c:f>'SN Ratio tumors'!$T$3</c:f>
              <c:strCache>
                <c:ptCount val="1"/>
                <c:pt idx="0">
                  <c:v>Noise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strRef>
              <c:f>'SN Ratio tumors'!$U$1:$Y$1</c:f>
              <c:strCache>
                <c:ptCount val="5"/>
                <c:pt idx="0">
                  <c:v>10ug/ml</c:v>
                </c:pt>
                <c:pt idx="1">
                  <c:v>4ug/ml</c:v>
                </c:pt>
                <c:pt idx="2">
                  <c:v>2ug/ml</c:v>
                </c:pt>
                <c:pt idx="3">
                  <c:v>1ug/ml</c:v>
                </c:pt>
                <c:pt idx="4">
                  <c:v>0.4ug/ml</c:v>
                </c:pt>
              </c:strCache>
            </c:strRef>
          </c:cat>
          <c:val>
            <c:numRef>
              <c:f>'SN Ratio tumors'!$U$3:$Y$3</c:f>
              <c:numCache>
                <c:formatCode>General</c:formatCode>
                <c:ptCount val="5"/>
                <c:pt idx="0">
                  <c:v>589.82255000000009</c:v>
                </c:pt>
                <c:pt idx="1">
                  <c:v>300.19077499999997</c:v>
                </c:pt>
                <c:pt idx="2">
                  <c:v>210.10047499999999</c:v>
                </c:pt>
                <c:pt idx="3">
                  <c:v>95.685659999999999</c:v>
                </c:pt>
                <c:pt idx="4">
                  <c:v>71.0445674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D2F-8D48-868E-3F9324BFE46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203239871"/>
        <c:axId val="1203237791"/>
      </c:lineChart>
      <c:lineChart>
        <c:grouping val="standard"/>
        <c:varyColors val="0"/>
        <c:ser>
          <c:idx val="2"/>
          <c:order val="2"/>
          <c:tx>
            <c:strRef>
              <c:f>'SN Ratio tumors'!$T$4</c:f>
              <c:strCache>
                <c:ptCount val="1"/>
                <c:pt idx="0">
                  <c:v>S:N Ratio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dLbls>
            <c:dLbl>
              <c:idx val="0"/>
              <c:tx>
                <c:rich>
                  <a:bodyPr/>
                  <a:lstStyle/>
                  <a:p>
                    <a:fld id="{A80FAA0C-2A16-E54C-8658-47B3773F9F55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2-5D2F-8D48-868E-3F9324BFE467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fld id="{8AAA1ABB-DC62-2643-953E-A5FE3F4D6072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3-5D2F-8D48-868E-3F9324BFE467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fld id="{5D3B4D9C-0F17-0440-9711-837FC4F6E51B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4-5D2F-8D48-868E-3F9324BFE467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fld id="{C463F9A5-33A0-F941-A0C0-E9A66ABE229C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5-5D2F-8D48-868E-3F9324BFE467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E0B10606-2AF5-CB41-9BF9-2829E583E1AC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6-5D2F-8D48-868E-3F9324BFE467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cat>
            <c:strRef>
              <c:f>'SN Ratio tumors'!$U$1:$Y$1</c:f>
              <c:strCache>
                <c:ptCount val="5"/>
                <c:pt idx="0">
                  <c:v>10ug/ml</c:v>
                </c:pt>
                <c:pt idx="1">
                  <c:v>4ug/ml</c:v>
                </c:pt>
                <c:pt idx="2">
                  <c:v>2ug/ml</c:v>
                </c:pt>
                <c:pt idx="3">
                  <c:v>1ug/ml</c:v>
                </c:pt>
                <c:pt idx="4">
                  <c:v>0.4ug/ml</c:v>
                </c:pt>
              </c:strCache>
            </c:strRef>
          </c:cat>
          <c:val>
            <c:numRef>
              <c:f>'SN Ratio tumors'!$U$4:$Y$4</c:f>
              <c:numCache>
                <c:formatCode>0</c:formatCode>
                <c:ptCount val="5"/>
                <c:pt idx="0">
                  <c:v>13.39273057634029</c:v>
                </c:pt>
                <c:pt idx="1">
                  <c:v>24.464389353736806</c:v>
                </c:pt>
                <c:pt idx="2">
                  <c:v>33.960224268888496</c:v>
                </c:pt>
                <c:pt idx="3">
                  <c:v>62.053585145360337</c:v>
                </c:pt>
                <c:pt idx="4">
                  <c:v>54.569299053020487</c:v>
                </c:pt>
              </c:numCache>
            </c:numRef>
          </c:val>
          <c:smooth val="0"/>
          <c:extLst>
            <c:ext xmlns:c15="http://schemas.microsoft.com/office/drawing/2012/chart" uri="{02D57815-91ED-43cb-92C2-25804820EDAC}">
              <c15:datalabelsRange>
                <c15:f>'SN Ratio tumors'!$U$4:$Y$4</c15:f>
                <c15:dlblRangeCache>
                  <c:ptCount val="5"/>
                  <c:pt idx="0">
                    <c:v>13</c:v>
                  </c:pt>
                  <c:pt idx="1">
                    <c:v>24</c:v>
                  </c:pt>
                  <c:pt idx="2">
                    <c:v>34</c:v>
                  </c:pt>
                  <c:pt idx="3">
                    <c:v>62</c:v>
                  </c:pt>
                  <c:pt idx="4">
                    <c:v>55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07-5D2F-8D48-868E-3F9324BFE46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203241535"/>
        <c:axId val="1203238623"/>
      </c:lineChart>
      <c:catAx>
        <c:axId val="120323987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Antibody Concentrat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03237791"/>
        <c:crosses val="autoZero"/>
        <c:auto val="1"/>
        <c:lblAlgn val="ctr"/>
        <c:lblOffset val="100"/>
        <c:noMultiLvlLbl val="0"/>
      </c:catAx>
      <c:valAx>
        <c:axId val="120323779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FQS5276</a:t>
                </a:r>
                <a:r>
                  <a:rPr lang="en-US" baseline="0" dirty="0"/>
                  <a:t> in tumors-AQUA Score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1.1219043428928693E-2"/>
              <c:y val="0.1283061505157394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03239871"/>
        <c:crosses val="autoZero"/>
        <c:crossBetween val="between"/>
      </c:valAx>
      <c:valAx>
        <c:axId val="1203238623"/>
        <c:scaling>
          <c:orientation val="minMax"/>
        </c:scaling>
        <c:delete val="0"/>
        <c:axPos val="r"/>
        <c:numFmt formatCode="0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03241535"/>
        <c:crosses val="max"/>
        <c:crossBetween val="between"/>
      </c:valAx>
      <c:catAx>
        <c:axId val="1203241535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203238623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6304956567520135"/>
          <c:y val="0.90681983794754428"/>
          <c:w val="0.67390056900159379"/>
          <c:h val="9.318016205245574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8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b="1"/>
              <a:t>MM0107 CLON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7862582242987704"/>
          <c:y val="0.17171296296296296"/>
          <c:w val="0.76355665113465776"/>
          <c:h val="0.55399654226228312"/>
        </c:manualLayout>
      </c:layout>
      <c:lineChart>
        <c:grouping val="standard"/>
        <c:varyColors val="0"/>
        <c:ser>
          <c:idx val="0"/>
          <c:order val="0"/>
          <c:tx>
            <c:strRef>
              <c:f>'SN RATIO MM0107'!$O$2</c:f>
              <c:strCache>
                <c:ptCount val="1"/>
                <c:pt idx="0">
                  <c:v>Signal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'SN RATIO MM0107'!$P$1:$T$1</c:f>
              <c:strCache>
                <c:ptCount val="5"/>
                <c:pt idx="0">
                  <c:v>15ug/ml</c:v>
                </c:pt>
                <c:pt idx="1">
                  <c:v> 10ug/ml</c:v>
                </c:pt>
                <c:pt idx="2">
                  <c:v> 5ug/ml</c:v>
                </c:pt>
                <c:pt idx="3">
                  <c:v>1ug/ml</c:v>
                </c:pt>
                <c:pt idx="4">
                  <c:v>0.5ug/ml</c:v>
                </c:pt>
              </c:strCache>
            </c:strRef>
          </c:cat>
          <c:val>
            <c:numRef>
              <c:f>'SN RATIO MM0107'!$P$2:$T$2</c:f>
              <c:numCache>
                <c:formatCode>0</c:formatCode>
                <c:ptCount val="5"/>
                <c:pt idx="0">
                  <c:v>936.93</c:v>
                </c:pt>
                <c:pt idx="1">
                  <c:v>412.5</c:v>
                </c:pt>
                <c:pt idx="2">
                  <c:v>448.47</c:v>
                </c:pt>
                <c:pt idx="3">
                  <c:v>221.31</c:v>
                </c:pt>
                <c:pt idx="4">
                  <c:v>163.08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0A8-B74B-84D8-79DB4136B58D}"/>
            </c:ext>
          </c:extLst>
        </c:ser>
        <c:ser>
          <c:idx val="1"/>
          <c:order val="1"/>
          <c:tx>
            <c:strRef>
              <c:f>'SN RATIO MM0107'!$O$3</c:f>
              <c:strCache>
                <c:ptCount val="1"/>
                <c:pt idx="0">
                  <c:v>Noise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strRef>
              <c:f>'SN RATIO MM0107'!$P$1:$T$1</c:f>
              <c:strCache>
                <c:ptCount val="5"/>
                <c:pt idx="0">
                  <c:v>15ug/ml</c:v>
                </c:pt>
                <c:pt idx="1">
                  <c:v> 10ug/ml</c:v>
                </c:pt>
                <c:pt idx="2">
                  <c:v> 5ug/ml</c:v>
                </c:pt>
                <c:pt idx="3">
                  <c:v>1ug/ml</c:v>
                </c:pt>
                <c:pt idx="4">
                  <c:v>0.5ug/ml</c:v>
                </c:pt>
              </c:strCache>
            </c:strRef>
          </c:cat>
          <c:val>
            <c:numRef>
              <c:f>'SN RATIO MM0107'!$P$3:$T$3</c:f>
              <c:numCache>
                <c:formatCode>0</c:formatCode>
                <c:ptCount val="5"/>
                <c:pt idx="0">
                  <c:v>184.34</c:v>
                </c:pt>
                <c:pt idx="1">
                  <c:v>111.05</c:v>
                </c:pt>
                <c:pt idx="2">
                  <c:v>123.91</c:v>
                </c:pt>
                <c:pt idx="3">
                  <c:v>75.98</c:v>
                </c:pt>
                <c:pt idx="4">
                  <c:v>68.4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0A8-B74B-84D8-79DB4136B58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70030608"/>
        <c:axId val="570027280"/>
      </c:lineChart>
      <c:lineChart>
        <c:grouping val="standard"/>
        <c:varyColors val="0"/>
        <c:ser>
          <c:idx val="2"/>
          <c:order val="2"/>
          <c:tx>
            <c:strRef>
              <c:f>'SN RATIO MM0107'!$O$4</c:f>
              <c:strCache>
                <c:ptCount val="1"/>
                <c:pt idx="0">
                  <c:v>S:N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dLbls>
            <c:dLbl>
              <c:idx val="0"/>
              <c:layout>
                <c:manualLayout>
                  <c:x val="-8.4546124663756744E-2"/>
                  <c:y val="-4.44735383488312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10A8-B74B-84D8-79DB4136B58D}"/>
                </c:ext>
              </c:extLst>
            </c:dLbl>
            <c:dLbl>
              <c:idx val="1"/>
              <c:layout>
                <c:manualLayout>
                  <c:x val="-8.3333333333333835E-3"/>
                  <c:y val="-5.5555555555555601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10A8-B74B-84D8-79DB4136B58D}"/>
                </c:ext>
              </c:extLst>
            </c:dLbl>
            <c:dLbl>
              <c:idx val="2"/>
              <c:layout>
                <c:manualLayout>
                  <c:x val="0"/>
                  <c:y val="-1.8518518518518517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10A8-B74B-84D8-79DB4136B58D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N RATIO MM0107'!$P$1:$T$1</c:f>
              <c:strCache>
                <c:ptCount val="5"/>
                <c:pt idx="0">
                  <c:v>15ug/ml</c:v>
                </c:pt>
                <c:pt idx="1">
                  <c:v> 10ug/ml</c:v>
                </c:pt>
                <c:pt idx="2">
                  <c:v> 5ug/ml</c:v>
                </c:pt>
                <c:pt idx="3">
                  <c:v>1ug/ml</c:v>
                </c:pt>
                <c:pt idx="4">
                  <c:v>0.5ug/ml</c:v>
                </c:pt>
              </c:strCache>
            </c:strRef>
          </c:cat>
          <c:val>
            <c:numRef>
              <c:f>'SN RATIO MM0107'!$P$4:$T$4</c:f>
              <c:numCache>
                <c:formatCode>0</c:formatCode>
                <c:ptCount val="5"/>
                <c:pt idx="0">
                  <c:v>5.0826190734512311</c:v>
                </c:pt>
                <c:pt idx="1">
                  <c:v>3.7145429986492573</c:v>
                </c:pt>
                <c:pt idx="2">
                  <c:v>3.6193204745379712</c:v>
                </c:pt>
                <c:pt idx="3">
                  <c:v>2.912740194788102</c:v>
                </c:pt>
                <c:pt idx="4">
                  <c:v>2.382468955441928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10A8-B74B-84D8-79DB4136B58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70018960"/>
        <c:axId val="570015632"/>
      </c:lineChart>
      <c:catAx>
        <c:axId val="57003060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Antibody Concentration</a:t>
                </a:r>
              </a:p>
            </c:rich>
          </c:tx>
          <c:layout>
            <c:manualLayout>
              <c:xMode val="edge"/>
              <c:yMode val="edge"/>
              <c:x val="0.37681933508311455"/>
              <c:y val="0.8283326042578010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70027280"/>
        <c:crosses val="autoZero"/>
        <c:auto val="1"/>
        <c:lblAlgn val="ctr"/>
        <c:lblOffset val="100"/>
        <c:noMultiLvlLbl val="0"/>
      </c:catAx>
      <c:valAx>
        <c:axId val="57002728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MM0107 in tumors AQUA scor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70030608"/>
        <c:crosses val="autoZero"/>
        <c:crossBetween val="between"/>
      </c:valAx>
      <c:valAx>
        <c:axId val="570015632"/>
        <c:scaling>
          <c:orientation val="minMax"/>
        </c:scaling>
        <c:delete val="0"/>
        <c:axPos val="r"/>
        <c:numFmt formatCode="0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70018960"/>
        <c:crosses val="max"/>
        <c:crossBetween val="between"/>
      </c:valAx>
      <c:catAx>
        <c:axId val="57001896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570015632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7796798378243542"/>
          <c:y val="0.89891223005793197"/>
          <c:w val="0.64406403243512922"/>
          <c:h val="0.101087769942067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8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 algn="ctr" rtl="0">
              <a:defRPr lang="en-US" sz="96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96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rPr>
              <a:t>MCA1982 CLONE</a:t>
            </a: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5189125979784884"/>
          <c:y val="0.17171296296296296"/>
          <c:w val="0.79029121376668587"/>
          <c:h val="0.56696471522336422"/>
        </c:manualLayout>
      </c:layout>
      <c:lineChart>
        <c:grouping val="standard"/>
        <c:varyColors val="0"/>
        <c:ser>
          <c:idx val="0"/>
          <c:order val="0"/>
          <c:tx>
            <c:strRef>
              <c:f>'SN RATIO MCA1982'!$R$2</c:f>
              <c:strCache>
                <c:ptCount val="1"/>
                <c:pt idx="0">
                  <c:v>SIGNAL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'SN RATIO MCA1982'!$S$1:$W$1</c:f>
              <c:strCache>
                <c:ptCount val="5"/>
                <c:pt idx="0">
                  <c:v>10ug/ml</c:v>
                </c:pt>
                <c:pt idx="1">
                  <c:v>5ug/ml</c:v>
                </c:pt>
                <c:pt idx="2">
                  <c:v>1ug/ml</c:v>
                </c:pt>
                <c:pt idx="3">
                  <c:v>0.5ug/ml</c:v>
                </c:pt>
                <c:pt idx="4">
                  <c:v>0.1ug/ml</c:v>
                </c:pt>
              </c:strCache>
            </c:strRef>
          </c:cat>
          <c:val>
            <c:numRef>
              <c:f>'SN RATIO MCA1982'!$S$2:$W$2</c:f>
              <c:numCache>
                <c:formatCode>0</c:formatCode>
                <c:ptCount val="5"/>
                <c:pt idx="0">
                  <c:v>334.45</c:v>
                </c:pt>
                <c:pt idx="1">
                  <c:v>433.47</c:v>
                </c:pt>
                <c:pt idx="2">
                  <c:v>364</c:v>
                </c:pt>
                <c:pt idx="3">
                  <c:v>488</c:v>
                </c:pt>
                <c:pt idx="4">
                  <c:v>217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8CE-D74E-888D-D978F9004580}"/>
            </c:ext>
          </c:extLst>
        </c:ser>
        <c:ser>
          <c:idx val="1"/>
          <c:order val="1"/>
          <c:tx>
            <c:strRef>
              <c:f>'SN RATIO MCA1982'!$R$3</c:f>
              <c:strCache>
                <c:ptCount val="1"/>
                <c:pt idx="0">
                  <c:v>NOISE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strRef>
              <c:f>'SN RATIO MCA1982'!$S$1:$W$1</c:f>
              <c:strCache>
                <c:ptCount val="5"/>
                <c:pt idx="0">
                  <c:v>10ug/ml</c:v>
                </c:pt>
                <c:pt idx="1">
                  <c:v>5ug/ml</c:v>
                </c:pt>
                <c:pt idx="2">
                  <c:v>1ug/ml</c:v>
                </c:pt>
                <c:pt idx="3">
                  <c:v>0.5ug/ml</c:v>
                </c:pt>
                <c:pt idx="4">
                  <c:v>0.1ug/ml</c:v>
                </c:pt>
              </c:strCache>
            </c:strRef>
          </c:cat>
          <c:val>
            <c:numRef>
              <c:f>'SN RATIO MCA1982'!$S$3:$W$3</c:f>
              <c:numCache>
                <c:formatCode>0</c:formatCode>
                <c:ptCount val="5"/>
                <c:pt idx="0">
                  <c:v>55.02</c:v>
                </c:pt>
                <c:pt idx="1">
                  <c:v>79.42</c:v>
                </c:pt>
                <c:pt idx="2">
                  <c:v>68.38</c:v>
                </c:pt>
                <c:pt idx="3">
                  <c:v>80.680000000000007</c:v>
                </c:pt>
                <c:pt idx="4">
                  <c:v>53.5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8CE-D74E-888D-D978F90045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70030608"/>
        <c:axId val="570027280"/>
      </c:lineChart>
      <c:lineChart>
        <c:grouping val="standard"/>
        <c:varyColors val="0"/>
        <c:ser>
          <c:idx val="2"/>
          <c:order val="2"/>
          <c:tx>
            <c:strRef>
              <c:f>'SN RATIO MCA1982'!$R$4</c:f>
              <c:strCache>
                <c:ptCount val="1"/>
                <c:pt idx="0">
                  <c:v>S:N Ratio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dLbls>
            <c:dLbl>
              <c:idx val="0"/>
              <c:layout>
                <c:manualLayout>
                  <c:x val="-4.4444444444444495E-2"/>
                  <c:y val="-5.0925925925925972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A8CE-D74E-888D-D978F9004580}"/>
                </c:ext>
              </c:extLst>
            </c:dLbl>
            <c:dLbl>
              <c:idx val="1"/>
              <c:layout>
                <c:manualLayout>
                  <c:x val="-8.3333333333333835E-3"/>
                  <c:y val="-5.5555555555555601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A8CE-D74E-888D-D978F9004580}"/>
                </c:ext>
              </c:extLst>
            </c:dLbl>
            <c:dLbl>
              <c:idx val="2"/>
              <c:layout>
                <c:manualLayout>
                  <c:x val="-5.5555555555555558E-3"/>
                  <c:y val="-6.018518518518523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A8CE-D74E-888D-D978F9004580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vert="horz"/>
              <a:lstStyle/>
              <a:p>
                <a:pPr>
                  <a:defRPr/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N RATIO MCA1982'!$S$1:$W$1</c:f>
              <c:strCache>
                <c:ptCount val="5"/>
                <c:pt idx="0">
                  <c:v>10ug/ml</c:v>
                </c:pt>
                <c:pt idx="1">
                  <c:v>5ug/ml</c:v>
                </c:pt>
                <c:pt idx="2">
                  <c:v>1ug/ml</c:v>
                </c:pt>
                <c:pt idx="3">
                  <c:v>0.5ug/ml</c:v>
                </c:pt>
                <c:pt idx="4">
                  <c:v>0.1ug/ml</c:v>
                </c:pt>
              </c:strCache>
            </c:strRef>
          </c:cat>
          <c:val>
            <c:numRef>
              <c:f>'SN RATIO MCA1982'!$S$4:$W$4</c:f>
              <c:numCache>
                <c:formatCode>0</c:formatCode>
                <c:ptCount val="5"/>
                <c:pt idx="0">
                  <c:v>6.0786986550345325</c:v>
                </c:pt>
                <c:pt idx="1">
                  <c:v>5.4579451019894236</c:v>
                </c:pt>
                <c:pt idx="2">
                  <c:v>5.3231939163498101</c:v>
                </c:pt>
                <c:pt idx="3">
                  <c:v>6.0485870104115014</c:v>
                </c:pt>
                <c:pt idx="4">
                  <c:v>4.053751399776035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A8CE-D74E-888D-D978F90045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70018960"/>
        <c:axId val="570015632"/>
      </c:lineChart>
      <c:catAx>
        <c:axId val="570030608"/>
        <c:scaling>
          <c:orientation val="minMax"/>
        </c:scaling>
        <c:delete val="0"/>
        <c:axPos val="b"/>
        <c:title>
          <c:tx>
            <c:rich>
              <a:bodyPr rot="0" vert="horz"/>
              <a:lstStyle/>
              <a:p>
                <a:pPr algn="ctr" rtl="0">
                  <a:defRPr lang="en-US" sz="8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8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rPr>
                  <a:t>Antibody Concentration</a:t>
                </a:r>
              </a:p>
            </c:rich>
          </c:tx>
          <c:layout>
            <c:manualLayout>
              <c:xMode val="edge"/>
              <c:yMode val="edge"/>
              <c:x val="0.37681933508311455"/>
              <c:y val="0.82833260425780109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570027280"/>
        <c:crosses val="autoZero"/>
        <c:auto val="1"/>
        <c:lblAlgn val="ctr"/>
        <c:lblOffset val="100"/>
        <c:noMultiLvlLbl val="0"/>
      </c:catAx>
      <c:valAx>
        <c:axId val="57002728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 algn="ctr" rtl="0">
                  <a:defRPr lang="en-US" sz="8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8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rPr>
                  <a:t>MM0107 in tumors AQUA scor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570030608"/>
        <c:crosses val="autoZero"/>
        <c:crossBetween val="between"/>
      </c:valAx>
      <c:valAx>
        <c:axId val="570015632"/>
        <c:scaling>
          <c:orientation val="minMax"/>
        </c:scaling>
        <c:delete val="0"/>
        <c:axPos val="r"/>
        <c:numFmt formatCode="0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570018960"/>
        <c:crosses val="max"/>
        <c:crossBetween val="between"/>
      </c:valAx>
      <c:catAx>
        <c:axId val="57001896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570015632"/>
        <c:crosses val="autoZero"/>
        <c:auto val="1"/>
        <c:lblAlgn val="ctr"/>
        <c:lblOffset val="100"/>
        <c:noMultiLvlLbl val="0"/>
      </c:catAx>
    </c:plotArea>
    <c:legend>
      <c:legendPos val="b"/>
      <c:layout>
        <c:manualLayout>
          <c:xMode val="edge"/>
          <c:yMode val="edge"/>
          <c:x val="0.13734407908378338"/>
          <c:y val="0.89924530824175652"/>
          <c:w val="0.77878061624921102"/>
          <c:h val="0.10075469175824343"/>
        </c:manualLayout>
      </c:layout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 lang="en-US" sz="8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/>
  </c:chart>
  <c:spPr>
    <a:ln>
      <a:solidFill>
        <a:schemeClr val="tx1"/>
      </a:solidFill>
    </a:ln>
  </c:spPr>
  <c:txPr>
    <a:bodyPr/>
    <a:lstStyle/>
    <a:p>
      <a:pPr>
        <a:defRPr sz="800">
          <a:solidFill>
            <a:sysClr val="windowText" lastClr="000000"/>
          </a:solidFill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b="1" dirty="0"/>
              <a:t>FQS5276 clon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4805817606058164"/>
          <c:y val="0.17514986982586056"/>
          <c:w val="0.74498366768556989"/>
          <c:h val="0.5610535844410163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N ratio cell lines'!$T$3</c:f>
              <c:strCache>
                <c:ptCount val="1"/>
                <c:pt idx="0">
                  <c:v>Signal</c:v>
                </c:pt>
              </c:strCache>
            </c:strRef>
          </c:tx>
          <c:spPr>
            <a:solidFill>
              <a:schemeClr val="accent1"/>
            </a:solidFill>
            <a:ln w="28575" cap="rnd">
              <a:solidFill>
                <a:schemeClr val="accent1"/>
              </a:solidFill>
              <a:round/>
            </a:ln>
            <a:effectLst/>
          </c:spPr>
          <c:invertIfNegative val="0"/>
          <c:dLbls>
            <c:delete val="1"/>
          </c:dLbls>
          <c:cat>
            <c:strRef>
              <c:f>'SN ratio cell lines'!$U$2:$Y$2</c:f>
              <c:strCache>
                <c:ptCount val="5"/>
                <c:pt idx="0">
                  <c:v>10ug/ml</c:v>
                </c:pt>
                <c:pt idx="1">
                  <c:v>4ug/ml</c:v>
                </c:pt>
                <c:pt idx="2">
                  <c:v>2ug/ml</c:v>
                </c:pt>
                <c:pt idx="3">
                  <c:v>1ug/ml</c:v>
                </c:pt>
                <c:pt idx="4">
                  <c:v>0.4ug/ml</c:v>
                </c:pt>
              </c:strCache>
            </c:strRef>
          </c:cat>
          <c:val>
            <c:numRef>
              <c:f>'SN ratio cell lines'!$U$3:$Y$3</c:f>
              <c:numCache>
                <c:formatCode>General</c:formatCode>
                <c:ptCount val="5"/>
                <c:pt idx="0">
                  <c:v>2598.9368333333332</c:v>
                </c:pt>
                <c:pt idx="1">
                  <c:v>2011.2878666666668</c:v>
                </c:pt>
                <c:pt idx="2">
                  <c:v>1504.6653833333332</c:v>
                </c:pt>
                <c:pt idx="3">
                  <c:v>1241.5799333333334</c:v>
                </c:pt>
                <c:pt idx="4">
                  <c:v>558.574500000000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2B6-DB4F-AFA6-40EA6775E9F2}"/>
            </c:ext>
          </c:extLst>
        </c:ser>
        <c:ser>
          <c:idx val="1"/>
          <c:order val="1"/>
          <c:tx>
            <c:strRef>
              <c:f>'SN ratio cell lines'!$T$4</c:f>
              <c:strCache>
                <c:ptCount val="1"/>
                <c:pt idx="0">
                  <c:v>Noise</c:v>
                </c:pt>
              </c:strCache>
            </c:strRef>
          </c:tx>
          <c:spPr>
            <a:solidFill>
              <a:schemeClr val="accent2"/>
            </a:solidFill>
            <a:ln w="28575" cap="rnd">
              <a:solidFill>
                <a:schemeClr val="accent2"/>
              </a:solidFill>
              <a:round/>
            </a:ln>
            <a:effectLst/>
          </c:spPr>
          <c:invertIfNegative val="0"/>
          <c:dLbls>
            <c:delete val="1"/>
          </c:dLbls>
          <c:cat>
            <c:strRef>
              <c:f>'SN ratio cell lines'!$U$2:$Y$2</c:f>
              <c:strCache>
                <c:ptCount val="5"/>
                <c:pt idx="0">
                  <c:v>10ug/ml</c:v>
                </c:pt>
                <c:pt idx="1">
                  <c:v>4ug/ml</c:v>
                </c:pt>
                <c:pt idx="2">
                  <c:v>2ug/ml</c:v>
                </c:pt>
                <c:pt idx="3">
                  <c:v>1ug/ml</c:v>
                </c:pt>
                <c:pt idx="4">
                  <c:v>0.4ug/ml</c:v>
                </c:pt>
              </c:strCache>
            </c:strRef>
          </c:cat>
          <c:val>
            <c:numRef>
              <c:f>'SN ratio cell lines'!$U$4:$Y$4</c:f>
              <c:numCache>
                <c:formatCode>General</c:formatCode>
                <c:ptCount val="5"/>
                <c:pt idx="0">
                  <c:v>576.2551666666667</c:v>
                </c:pt>
                <c:pt idx="1">
                  <c:v>383.67553333333331</c:v>
                </c:pt>
                <c:pt idx="2">
                  <c:v>218.24678333333335</c:v>
                </c:pt>
                <c:pt idx="3">
                  <c:v>149.83450000000002</c:v>
                </c:pt>
                <c:pt idx="4">
                  <c:v>107.67734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2B6-DB4F-AFA6-40EA6775E9F2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1623223727"/>
        <c:axId val="1623232047"/>
      </c:barChart>
      <c:lineChart>
        <c:grouping val="standard"/>
        <c:varyColors val="0"/>
        <c:ser>
          <c:idx val="2"/>
          <c:order val="2"/>
          <c:tx>
            <c:strRef>
              <c:f>'SN ratio cell lines'!$T$5</c:f>
              <c:strCache>
                <c:ptCount val="1"/>
                <c:pt idx="0">
                  <c:v>S:N Ratio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N ratio cell lines'!$U$2:$Y$2</c:f>
              <c:strCache>
                <c:ptCount val="5"/>
                <c:pt idx="0">
                  <c:v>10ug/ml</c:v>
                </c:pt>
                <c:pt idx="1">
                  <c:v>4ug/ml</c:v>
                </c:pt>
                <c:pt idx="2">
                  <c:v>2ug/ml</c:v>
                </c:pt>
                <c:pt idx="3">
                  <c:v>1ug/ml</c:v>
                </c:pt>
                <c:pt idx="4">
                  <c:v>0.4ug/ml</c:v>
                </c:pt>
              </c:strCache>
            </c:strRef>
          </c:cat>
          <c:val>
            <c:numRef>
              <c:f>'SN ratio cell lines'!$U$5:$Y$5</c:f>
              <c:numCache>
                <c:formatCode>0.0</c:formatCode>
                <c:ptCount val="5"/>
                <c:pt idx="0">
                  <c:v>4.5100451738538272</c:v>
                </c:pt>
                <c:pt idx="1">
                  <c:v>5.2421582611557378</c:v>
                </c:pt>
                <c:pt idx="2">
                  <c:v>6.8943301722583605</c:v>
                </c:pt>
                <c:pt idx="3">
                  <c:v>8.286342153064437</c:v>
                </c:pt>
                <c:pt idx="4">
                  <c:v>5.187484039895363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32B6-DB4F-AFA6-40EA6775E9F2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marker val="1"/>
        <c:smooth val="0"/>
        <c:axId val="1623219983"/>
        <c:axId val="1623222063"/>
      </c:lineChart>
      <c:catAx>
        <c:axId val="1623223727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Antibody Conentrat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23232047"/>
        <c:crosses val="autoZero"/>
        <c:auto val="1"/>
        <c:lblAlgn val="ctr"/>
        <c:lblOffset val="100"/>
        <c:noMultiLvlLbl val="0"/>
      </c:catAx>
      <c:valAx>
        <c:axId val="162323204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QS5276 in histospo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23223727"/>
        <c:crosses val="autoZero"/>
        <c:crossBetween val="between"/>
      </c:valAx>
      <c:valAx>
        <c:axId val="1623222063"/>
        <c:scaling>
          <c:orientation val="minMax"/>
        </c:scaling>
        <c:delete val="0"/>
        <c:axPos val="r"/>
        <c:numFmt formatCode="0.0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23219983"/>
        <c:crosses val="max"/>
        <c:crossBetween val="between"/>
      </c:valAx>
      <c:catAx>
        <c:axId val="1623219983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623222063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3237638602168797"/>
          <c:y val="0.88955126532741979"/>
          <c:w val="0.7441583948602295"/>
          <c:h val="0.103822071484476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8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B579C1-CB55-8E4F-A9FC-18B6DD205D4F}" type="datetimeFigureOut">
              <a:rPr lang="en-US" smtClean="0"/>
              <a:t>9/21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F1BF06-EF75-C544-BD05-C46AE23F1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22297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F1BF06-EF75-C544-BD05-C46AE23F18E6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60380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F1BF06-EF75-C544-BD05-C46AE23F18E6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20291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2D43DF-2429-0315-7DE9-DAD4C726F2D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A6245D2-64D7-D17B-EDFA-526AAF2C68F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41969A-68F8-C039-76D6-FB332B39A1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0FF4C6-A142-7542-9A67-F6EAD6C59719}" type="datetimeFigureOut">
              <a:rPr lang="en-US" smtClean="0"/>
              <a:t>9/2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8A5156-BA05-2B7D-54B2-34BB69E643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77B68A-BFCF-D70A-4737-280F28A3CC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4B24D-9D36-A549-A1CD-DCB46426F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6691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E23DA7-2C87-9DAA-CD12-D54B8CCA7D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2FFF5A4-A96B-2138-4FA6-6BBE83F992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94BE11-CC61-41A6-6112-D7FB9E05D5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0FF4C6-A142-7542-9A67-F6EAD6C59719}" type="datetimeFigureOut">
              <a:rPr lang="en-US" smtClean="0"/>
              <a:t>9/2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4BDF15-967B-1C90-A780-3C2ED0AD12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0FC507-2B27-3D04-AF4B-D930A5E708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4B24D-9D36-A549-A1CD-DCB46426F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89106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B171F68-C408-EA59-3195-3C879D81CEC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CCA6540-3A9A-A94D-98F1-978B92B091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4E4B1C-955D-5F89-2152-DF4F191A14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0FF4C6-A142-7542-9A67-F6EAD6C59719}" type="datetimeFigureOut">
              <a:rPr lang="en-US" smtClean="0"/>
              <a:t>9/2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F0A0D9-76AA-B0AA-2B09-7D469BA9BC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747DFE-B34A-FF1C-CE70-294674908B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4B24D-9D36-A549-A1CD-DCB46426F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97346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7A67C8-0C15-ABF1-C768-D5E6E5F37B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FC6801-1690-3299-26FA-C06384EB239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CE8E83-2DF1-A8BC-A421-3912B0F1E4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0FF4C6-A142-7542-9A67-F6EAD6C59719}" type="datetimeFigureOut">
              <a:rPr lang="en-US" smtClean="0"/>
              <a:t>9/2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2350C5-792F-9B09-B29A-DEE944538C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9FB711-2C51-615C-8583-99A62E55A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4B24D-9D36-A549-A1CD-DCB46426F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41947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CAD98E-4F32-6B79-6888-33C0130C36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904E6F-67B0-36D6-BD55-04506D7316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DD5A3B-2BD3-7AA9-92EA-58AE462035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0FF4C6-A142-7542-9A67-F6EAD6C59719}" type="datetimeFigureOut">
              <a:rPr lang="en-US" smtClean="0"/>
              <a:t>9/2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43A726-B8BE-90B7-16C4-1AFC3772FF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FD5365-4212-A8FA-8D26-18CAF17977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4B24D-9D36-A549-A1CD-DCB46426F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174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684424-FB44-F7DD-34E5-89534C1863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C18339-821A-FB47-A42B-9B0854E1E49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A7D7306-3A8E-3B5D-127F-BBDF51CD49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E98D682-776E-9900-5BD0-D46DC5DA7D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0FF4C6-A142-7542-9A67-F6EAD6C59719}" type="datetimeFigureOut">
              <a:rPr lang="en-US" smtClean="0"/>
              <a:t>9/21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8A9BD5-308D-94E7-E63E-FC67228401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40FA467-4AFC-02B9-1E06-08B94EB89A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4B24D-9D36-A549-A1CD-DCB46426F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20857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6E33B3-28F7-34D0-2845-DB38449925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CF2502-6954-C940-84F1-2A691A8336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DD6F806-4363-3CF8-FEB6-8D3AFB18DAF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E5148EE-789E-0030-1CA7-5962706482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5341D1A-044C-2BA5-A9BD-B2C0BB3126A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0614614-385F-13DA-19C3-D5606B53E9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0FF4C6-A142-7542-9A67-F6EAD6C59719}" type="datetimeFigureOut">
              <a:rPr lang="en-US" smtClean="0"/>
              <a:t>9/21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BC52CE2-E66D-7DC5-BF3B-0011C5CDD7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341219A-8D5D-5422-386F-A06B1B0D6C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4B24D-9D36-A549-A1CD-DCB46426F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81963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09DCBB-EE4F-0416-F8A4-799ED97101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4E2FDE9-1AE4-1BD7-FBA9-0A91674EB4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0FF4C6-A142-7542-9A67-F6EAD6C59719}" type="datetimeFigureOut">
              <a:rPr lang="en-US" smtClean="0"/>
              <a:t>9/21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7C77C93-878B-5633-B507-C5EF9A588F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53089C4-BBE0-EBC5-A3B6-5ED858698E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4B24D-9D36-A549-A1CD-DCB46426F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33957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3774AC3-2897-A8C7-151B-FE9DA769AC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0FF4C6-A142-7542-9A67-F6EAD6C59719}" type="datetimeFigureOut">
              <a:rPr lang="en-US" smtClean="0"/>
              <a:t>9/21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F29207D-0E05-95B1-FA17-2EEACDC59F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FCF84C0-6602-6878-CA29-8398778DAB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4B24D-9D36-A549-A1CD-DCB46426F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27379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604476-43D8-C61D-E021-2D8D20C935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FC5629-8717-86D5-A7B4-E1AFA1793B0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38757F-2283-6803-3908-F8ED1857CA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8B961B-F6F3-F512-5B3D-4078192023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0FF4C6-A142-7542-9A67-F6EAD6C59719}" type="datetimeFigureOut">
              <a:rPr lang="en-US" smtClean="0"/>
              <a:t>9/21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6DC099-D435-AD7D-7FA6-4DC43A05D1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6A2AD25-526B-6956-27EA-51548CE2AB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4B24D-9D36-A549-A1CD-DCB46426F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88228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E8CDEF-99B3-347E-6E0A-189DEDDC0C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665090D-E643-104C-1BFF-27CEDFE7B09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093BC52-A896-4350-0027-C7C2A98497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6912E1-E90A-E79F-6767-89CB2856C0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0FF4C6-A142-7542-9A67-F6EAD6C59719}" type="datetimeFigureOut">
              <a:rPr lang="en-US" smtClean="0"/>
              <a:t>9/21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994D4FC-71EE-4113-0D39-30D7A597B2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06702F-E503-AB82-7A97-3197481B69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B4B24D-9D36-A549-A1CD-DCB46426F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56077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A8CC745-4C5A-7F20-4853-FB76295538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1EB1DC7-C480-8A63-0FCF-04433D71A1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46C71C-EFCC-CF33-C19F-20489AF23A0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0FF4C6-A142-7542-9A67-F6EAD6C59719}" type="datetimeFigureOut">
              <a:rPr lang="en-US" smtClean="0"/>
              <a:t>9/2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24D6BE-E935-008A-7164-7CFDCAF5649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A96C80-C7C9-08F5-D68D-BB2E8E9F023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B4B24D-9D36-A549-A1CD-DCB46426F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51009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6.png"/><Relationship Id="rId18" Type="http://schemas.microsoft.com/office/2007/relationships/hdphoto" Target="../media/hdphoto8.wdp"/><Relationship Id="rId26" Type="http://schemas.openxmlformats.org/officeDocument/2006/relationships/chart" Target="../charts/chart2.xml"/><Relationship Id="rId3" Type="http://schemas.openxmlformats.org/officeDocument/2006/relationships/image" Target="../media/image1.png"/><Relationship Id="rId21" Type="http://schemas.openxmlformats.org/officeDocument/2006/relationships/image" Target="../media/image11.png"/><Relationship Id="rId7" Type="http://schemas.openxmlformats.org/officeDocument/2006/relationships/image" Target="../media/image3.png"/><Relationship Id="rId12" Type="http://schemas.microsoft.com/office/2007/relationships/hdphoto" Target="../media/hdphoto5.wdp"/><Relationship Id="rId17" Type="http://schemas.openxmlformats.org/officeDocument/2006/relationships/image" Target="../media/image8.png"/><Relationship Id="rId25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6" Type="http://schemas.microsoft.com/office/2007/relationships/hdphoto" Target="../media/hdphoto7.wdp"/><Relationship Id="rId20" Type="http://schemas.openxmlformats.org/officeDocument/2006/relationships/image" Target="../media/image10.tmp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24" Type="http://schemas.microsoft.com/office/2007/relationships/hdphoto" Target="../media/hdphoto10.wdp"/><Relationship Id="rId5" Type="http://schemas.openxmlformats.org/officeDocument/2006/relationships/image" Target="../media/image2.png"/><Relationship Id="rId15" Type="http://schemas.openxmlformats.org/officeDocument/2006/relationships/image" Target="../media/image7.png"/><Relationship Id="rId23" Type="http://schemas.openxmlformats.org/officeDocument/2006/relationships/image" Target="../media/image12.png"/><Relationship Id="rId28" Type="http://schemas.openxmlformats.org/officeDocument/2006/relationships/chart" Target="../charts/chart4.xml"/><Relationship Id="rId10" Type="http://schemas.microsoft.com/office/2007/relationships/hdphoto" Target="../media/hdphoto4.wdp"/><Relationship Id="rId19" Type="http://schemas.openxmlformats.org/officeDocument/2006/relationships/image" Target="../media/image9.tmp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6.wdp"/><Relationship Id="rId22" Type="http://schemas.microsoft.com/office/2007/relationships/hdphoto" Target="../media/hdphoto9.wdp"/><Relationship Id="rId27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20.e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17.emf"/><Relationship Id="rId17" Type="http://schemas.openxmlformats.org/officeDocument/2006/relationships/oleObject" Target="../embeddings/oleObject8.bin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19.emf"/><Relationship Id="rId20" Type="http://schemas.openxmlformats.org/officeDocument/2006/relationships/image" Target="../media/image2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16.e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13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18.emf"/><Relationship Id="rId22" Type="http://schemas.openxmlformats.org/officeDocument/2006/relationships/image" Target="../media/image2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BA88FE-5E33-1CF7-7CE8-1555216C7339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upplementary figure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6478902-96B6-3617-DC04-1015DF914190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90102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4AB93EC3-2AE1-29F8-4454-58D320E9BC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0156" y="65210"/>
            <a:ext cx="6280442" cy="534020"/>
          </a:xfrm>
        </p:spPr>
        <p:txBody>
          <a:bodyPr>
            <a:noAutofit/>
          </a:bodyPr>
          <a:lstStyle/>
          <a:p>
            <a:r>
              <a:rPr lang="en-US" sz="2400" dirty="0"/>
              <a:t>Fig  S1. Antibody Validation</a:t>
            </a:r>
          </a:p>
        </p:txBody>
      </p:sp>
      <p:pic>
        <p:nvPicPr>
          <p:cNvPr id="5" name="Picture 4" descr="Graphical user interface&#10;&#10;Description automatically generated">
            <a:extLst>
              <a:ext uri="{FF2B5EF4-FFF2-40B4-BE49-F238E27FC236}">
                <a16:creationId xmlns:a16="http://schemas.microsoft.com/office/drawing/2014/main" id="{F45EDCF1-01CB-A994-3BF8-CA8D01D1E28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089" t="10738" r="1665" b="11468"/>
          <a:stretch/>
        </p:blipFill>
        <p:spPr>
          <a:xfrm>
            <a:off x="4169506" y="5399439"/>
            <a:ext cx="1364705" cy="139335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4C03BB5-0C59-F3B2-C9B5-29A1DE22952D}"/>
              </a:ext>
            </a:extLst>
          </p:cNvPr>
          <p:cNvSpPr txBox="1"/>
          <p:nvPr/>
        </p:nvSpPr>
        <p:spPr>
          <a:xfrm>
            <a:off x="4079595" y="3517496"/>
            <a:ext cx="15078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CA1982 @10ug/ml</a:t>
            </a:r>
          </a:p>
        </p:txBody>
      </p:sp>
      <p:pic>
        <p:nvPicPr>
          <p:cNvPr id="7" name="Picture 6" descr="A screenshot of a computer&#10;&#10;Description automatically generated with medium confidence">
            <a:extLst>
              <a:ext uri="{FF2B5EF4-FFF2-40B4-BE49-F238E27FC236}">
                <a16:creationId xmlns:a16="http://schemas.microsoft.com/office/drawing/2014/main" id="{B6EB131A-3183-6404-E036-A5EB3D4F71CC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73" t="5456" r="5829" b="23342"/>
          <a:stretch/>
        </p:blipFill>
        <p:spPr>
          <a:xfrm>
            <a:off x="3941541" y="3876202"/>
            <a:ext cx="1705011" cy="1511707"/>
          </a:xfrm>
          <a:prstGeom prst="rect">
            <a:avLst/>
          </a:prstGeom>
        </p:spPr>
      </p:pic>
      <p:pic>
        <p:nvPicPr>
          <p:cNvPr id="8" name="Picture 7" descr="Graphical user interface&#10;&#10;Description automatically generated">
            <a:extLst>
              <a:ext uri="{FF2B5EF4-FFF2-40B4-BE49-F238E27FC236}">
                <a16:creationId xmlns:a16="http://schemas.microsoft.com/office/drawing/2014/main" id="{D0626C71-3DA3-AEFF-99F5-8D1A9A7CDC74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119" t="20879" r="4747" b="9550"/>
          <a:stretch/>
        </p:blipFill>
        <p:spPr>
          <a:xfrm>
            <a:off x="4022359" y="2074236"/>
            <a:ext cx="1519659" cy="1491235"/>
          </a:xfrm>
          <a:prstGeom prst="rect">
            <a:avLst/>
          </a:prstGeom>
        </p:spPr>
      </p:pic>
      <p:pic>
        <p:nvPicPr>
          <p:cNvPr id="9" name="Picture 8" descr="A picture containing text, display, different, screenshot&#10;&#10;Description automatically generated">
            <a:extLst>
              <a:ext uri="{FF2B5EF4-FFF2-40B4-BE49-F238E27FC236}">
                <a16:creationId xmlns:a16="http://schemas.microsoft.com/office/drawing/2014/main" id="{BD370D15-C3BB-14C0-C052-24140412EAFF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20" t="5316" r="18120" b="21968"/>
          <a:stretch/>
        </p:blipFill>
        <p:spPr>
          <a:xfrm>
            <a:off x="3896120" y="568853"/>
            <a:ext cx="1705010" cy="1499257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44BBC518-4CC0-EFBB-B274-CEB00A7548D9}"/>
              </a:ext>
            </a:extLst>
          </p:cNvPr>
          <p:cNvSpPr/>
          <p:nvPr/>
        </p:nvSpPr>
        <p:spPr>
          <a:xfrm>
            <a:off x="4766050" y="2285523"/>
            <a:ext cx="499042" cy="35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1" name="Picture 10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F530ED3E-048B-9019-A822-AF43536FAFE0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893" t="10434" r="8952" b="12603"/>
          <a:stretch/>
        </p:blipFill>
        <p:spPr>
          <a:xfrm>
            <a:off x="2265969" y="5392627"/>
            <a:ext cx="1364705" cy="1393802"/>
          </a:xfrm>
          <a:prstGeom prst="rect">
            <a:avLst/>
          </a:prstGeom>
        </p:spPr>
      </p:pic>
      <p:pic>
        <p:nvPicPr>
          <p:cNvPr id="12" name="Picture 11" descr="A screenshot of a map&#10;&#10;Description automatically generated with low confidence">
            <a:extLst>
              <a:ext uri="{FF2B5EF4-FFF2-40B4-BE49-F238E27FC236}">
                <a16:creationId xmlns:a16="http://schemas.microsoft.com/office/drawing/2014/main" id="{6FE6A493-D901-B759-19D5-23B6D08D955A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32" t="9246" r="21367" b="10976"/>
          <a:stretch/>
        </p:blipFill>
        <p:spPr>
          <a:xfrm>
            <a:off x="2115941" y="3866248"/>
            <a:ext cx="1675572" cy="1547692"/>
          </a:xfrm>
          <a:prstGeom prst="rect">
            <a:avLst/>
          </a:prstGeom>
        </p:spPr>
      </p:pic>
      <p:sp>
        <p:nvSpPr>
          <p:cNvPr id="13" name="Rectangle 12">
            <a:extLst>
              <a:ext uri="{FF2B5EF4-FFF2-40B4-BE49-F238E27FC236}">
                <a16:creationId xmlns:a16="http://schemas.microsoft.com/office/drawing/2014/main" id="{CA15C31F-6B22-23CC-EB27-00F1AE21A000}"/>
              </a:ext>
            </a:extLst>
          </p:cNvPr>
          <p:cNvSpPr/>
          <p:nvPr/>
        </p:nvSpPr>
        <p:spPr>
          <a:xfrm>
            <a:off x="2550700" y="5904282"/>
            <a:ext cx="499042" cy="35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BC21944C-4ED0-2677-8CD1-18F023158694}"/>
              </a:ext>
            </a:extLst>
          </p:cNvPr>
          <p:cNvSpPr/>
          <p:nvPr/>
        </p:nvSpPr>
        <p:spPr>
          <a:xfrm>
            <a:off x="5090368" y="6164186"/>
            <a:ext cx="499042" cy="35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D464064-4117-8BEF-65CB-B881CBD88F27}"/>
              </a:ext>
            </a:extLst>
          </p:cNvPr>
          <p:cNvSpPr txBox="1"/>
          <p:nvPr/>
        </p:nvSpPr>
        <p:spPr>
          <a:xfrm>
            <a:off x="2211811" y="3517496"/>
            <a:ext cx="14677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M0107 @15ug/ml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DDEDB18-E75E-B68D-4F87-14116D22873B}"/>
              </a:ext>
            </a:extLst>
          </p:cNvPr>
          <p:cNvSpPr txBox="1"/>
          <p:nvPr/>
        </p:nvSpPr>
        <p:spPr>
          <a:xfrm>
            <a:off x="537242" y="3501789"/>
            <a:ext cx="14359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FQS5276 @1ug/ml</a:t>
            </a:r>
          </a:p>
        </p:txBody>
      </p:sp>
      <p:pic>
        <p:nvPicPr>
          <p:cNvPr id="17" name="Picture 16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87A71622-FC9E-44FC-FB25-F7ACFC3197F8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89" t="5133" r="8644" b="12442"/>
          <a:stretch/>
        </p:blipFill>
        <p:spPr>
          <a:xfrm>
            <a:off x="2224899" y="1979149"/>
            <a:ext cx="1519659" cy="1575693"/>
          </a:xfrm>
          <a:prstGeom prst="rect">
            <a:avLst/>
          </a:prstGeom>
        </p:spPr>
      </p:pic>
      <p:pic>
        <p:nvPicPr>
          <p:cNvPr id="18" name="Picture 17" descr="A picture containing text, electronics, display, screenshot&#10;&#10;Description automatically generated">
            <a:extLst>
              <a:ext uri="{FF2B5EF4-FFF2-40B4-BE49-F238E27FC236}">
                <a16:creationId xmlns:a16="http://schemas.microsoft.com/office/drawing/2014/main" id="{296645C5-34AA-2ACC-5912-CCF869A8EB2E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74" t="17994" r="7219" b="9073"/>
          <a:stretch/>
        </p:blipFill>
        <p:spPr>
          <a:xfrm>
            <a:off x="2115941" y="561127"/>
            <a:ext cx="1739842" cy="1491235"/>
          </a:xfrm>
          <a:prstGeom prst="rect">
            <a:avLst/>
          </a:prstGeom>
        </p:spPr>
      </p:pic>
      <p:sp>
        <p:nvSpPr>
          <p:cNvPr id="19" name="Rectangle 18">
            <a:extLst>
              <a:ext uri="{FF2B5EF4-FFF2-40B4-BE49-F238E27FC236}">
                <a16:creationId xmlns:a16="http://schemas.microsoft.com/office/drawing/2014/main" id="{9F0A66F5-7DD6-E854-2ED2-97614A1AE0DE}"/>
              </a:ext>
            </a:extLst>
          </p:cNvPr>
          <p:cNvSpPr/>
          <p:nvPr/>
        </p:nvSpPr>
        <p:spPr>
          <a:xfrm>
            <a:off x="3085415" y="2332232"/>
            <a:ext cx="499042" cy="35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913A5B95-8652-B455-C9AD-B26FD3769945}"/>
              </a:ext>
            </a:extLst>
          </p:cNvPr>
          <p:cNvSpPr/>
          <p:nvPr/>
        </p:nvSpPr>
        <p:spPr>
          <a:xfrm>
            <a:off x="1611563" y="2423005"/>
            <a:ext cx="499042" cy="35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1" name="Picture 20" descr="A screenshot of a map&#10;&#10;Description automatically generated with medium confidence">
            <a:extLst>
              <a:ext uri="{FF2B5EF4-FFF2-40B4-BE49-F238E27FC236}">
                <a16:creationId xmlns:a16="http://schemas.microsoft.com/office/drawing/2014/main" id="{40B96A57-6425-4618-F2D6-69698BE67BC9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58" t="6662" r="8085" b="12095"/>
          <a:stretch/>
        </p:blipFill>
        <p:spPr>
          <a:xfrm>
            <a:off x="474829" y="5413940"/>
            <a:ext cx="1354939" cy="1414277"/>
          </a:xfrm>
          <a:prstGeom prst="rect">
            <a:avLst/>
          </a:prstGeom>
        </p:spPr>
      </p:pic>
      <p:pic>
        <p:nvPicPr>
          <p:cNvPr id="22" name="Picture 21" descr="A picture containing text, monitor, electronics, screen&#10;&#10;Description automatically generated">
            <a:extLst>
              <a:ext uri="{FF2B5EF4-FFF2-40B4-BE49-F238E27FC236}">
                <a16:creationId xmlns:a16="http://schemas.microsoft.com/office/drawing/2014/main" id="{580C8D7A-F669-1577-ACED-DA1114A3C1B5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42" t="5813" r="4349" b="17576"/>
          <a:stretch/>
        </p:blipFill>
        <p:spPr>
          <a:xfrm>
            <a:off x="312205" y="3891250"/>
            <a:ext cx="1660951" cy="1525890"/>
          </a:xfrm>
          <a:prstGeom prst="rect">
            <a:avLst/>
          </a:prstGeom>
        </p:spPr>
      </p:pic>
      <p:sp>
        <p:nvSpPr>
          <p:cNvPr id="23" name="Rectangle 22">
            <a:extLst>
              <a:ext uri="{FF2B5EF4-FFF2-40B4-BE49-F238E27FC236}">
                <a16:creationId xmlns:a16="http://schemas.microsoft.com/office/drawing/2014/main" id="{CFD1CB88-0934-BE07-5E29-45EA5101940D}"/>
              </a:ext>
            </a:extLst>
          </p:cNvPr>
          <p:cNvSpPr/>
          <p:nvPr/>
        </p:nvSpPr>
        <p:spPr>
          <a:xfrm>
            <a:off x="854662" y="5671113"/>
            <a:ext cx="499042" cy="35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4" name="Picture 23" descr="Map&#10;&#10;Description automatically generated">
            <a:extLst>
              <a:ext uri="{FF2B5EF4-FFF2-40B4-BE49-F238E27FC236}">
                <a16:creationId xmlns:a16="http://schemas.microsoft.com/office/drawing/2014/main" id="{D70CB6CC-43E1-14E9-9056-BDE35F87D467}"/>
              </a:ext>
            </a:extLst>
          </p:cNvPr>
          <p:cNvPicPr>
            <a:picLocks noChangeAspect="1"/>
          </p:cNvPicPr>
          <p:nvPr/>
        </p:nvPicPr>
        <p:blipFill rotWithShape="1">
          <a:blip r:embed="rId21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742" t="4849" r="6186" b="11295"/>
          <a:stretch/>
        </p:blipFill>
        <p:spPr>
          <a:xfrm>
            <a:off x="422087" y="2048616"/>
            <a:ext cx="1467775" cy="1519468"/>
          </a:xfrm>
          <a:prstGeom prst="rect">
            <a:avLst/>
          </a:prstGeom>
        </p:spPr>
      </p:pic>
      <p:pic>
        <p:nvPicPr>
          <p:cNvPr id="25" name="Picture 24" descr="A screenshot of a computer&#10;&#10;Description automatically generated with low confidence">
            <a:extLst>
              <a:ext uri="{FF2B5EF4-FFF2-40B4-BE49-F238E27FC236}">
                <a16:creationId xmlns:a16="http://schemas.microsoft.com/office/drawing/2014/main" id="{1984ADE5-5619-0073-25E0-8CC5E3BC83E4}"/>
              </a:ext>
            </a:extLst>
          </p:cNvPr>
          <p:cNvPicPr>
            <a:picLocks noChangeAspect="1"/>
          </p:cNvPicPr>
          <p:nvPr/>
        </p:nvPicPr>
        <p:blipFill rotWithShape="1">
          <a:blip r:embed="rId23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00" t="4713" r="7222" b="18420"/>
          <a:stretch/>
        </p:blipFill>
        <p:spPr>
          <a:xfrm>
            <a:off x="464950" y="574979"/>
            <a:ext cx="1610654" cy="1464192"/>
          </a:xfrm>
          <a:prstGeom prst="rect">
            <a:avLst/>
          </a:prstGeom>
        </p:spPr>
      </p:pic>
      <p:sp>
        <p:nvSpPr>
          <p:cNvPr id="26" name="Rectangle 25">
            <a:extLst>
              <a:ext uri="{FF2B5EF4-FFF2-40B4-BE49-F238E27FC236}">
                <a16:creationId xmlns:a16="http://schemas.microsoft.com/office/drawing/2014/main" id="{A6D04ED9-5817-6C47-FD6F-85C9A14E230D}"/>
              </a:ext>
            </a:extLst>
          </p:cNvPr>
          <p:cNvSpPr/>
          <p:nvPr/>
        </p:nvSpPr>
        <p:spPr>
          <a:xfrm>
            <a:off x="699451" y="2810232"/>
            <a:ext cx="499042" cy="35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27" name="Chart 26">
            <a:extLst>
              <a:ext uri="{FF2B5EF4-FFF2-40B4-BE49-F238E27FC236}">
                <a16:creationId xmlns:a16="http://schemas.microsoft.com/office/drawing/2014/main" id="{1C60B836-696E-A131-050F-A3DEA6C61F9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15345863"/>
              </p:ext>
            </p:extLst>
          </p:nvPr>
        </p:nvGraphicFramePr>
        <p:xfrm>
          <a:off x="8919670" y="555690"/>
          <a:ext cx="2850243" cy="19683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5"/>
          </a:graphicData>
        </a:graphic>
      </p:graphicFrame>
      <p:graphicFrame>
        <p:nvGraphicFramePr>
          <p:cNvPr id="28" name="Chart 27">
            <a:extLst>
              <a:ext uri="{FF2B5EF4-FFF2-40B4-BE49-F238E27FC236}">
                <a16:creationId xmlns:a16="http://schemas.microsoft.com/office/drawing/2014/main" id="{840067DA-B28F-4E50-B181-B5FD575C8C1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91972565"/>
              </p:ext>
            </p:extLst>
          </p:nvPr>
        </p:nvGraphicFramePr>
        <p:xfrm>
          <a:off x="5876167" y="2863674"/>
          <a:ext cx="2850243" cy="19683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6"/>
          </a:graphicData>
        </a:graphic>
      </p:graphicFrame>
      <p:graphicFrame>
        <p:nvGraphicFramePr>
          <p:cNvPr id="29" name="Chart 28">
            <a:extLst>
              <a:ext uri="{FF2B5EF4-FFF2-40B4-BE49-F238E27FC236}">
                <a16:creationId xmlns:a16="http://schemas.microsoft.com/office/drawing/2014/main" id="{31491AB4-3693-7601-92CA-1B0056E3A37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2562411"/>
              </p:ext>
            </p:extLst>
          </p:nvPr>
        </p:nvGraphicFramePr>
        <p:xfrm>
          <a:off x="8919670" y="2855256"/>
          <a:ext cx="2850243" cy="19748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7"/>
          </a:graphicData>
        </a:graphic>
      </p:graphicFrame>
      <p:graphicFrame>
        <p:nvGraphicFramePr>
          <p:cNvPr id="30" name="Chart 29">
            <a:extLst>
              <a:ext uri="{FF2B5EF4-FFF2-40B4-BE49-F238E27FC236}">
                <a16:creationId xmlns:a16="http://schemas.microsoft.com/office/drawing/2014/main" id="{58F200F2-1514-5230-172C-28021EB286B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64295086"/>
              </p:ext>
            </p:extLst>
          </p:nvPr>
        </p:nvGraphicFramePr>
        <p:xfrm>
          <a:off x="5863881" y="561127"/>
          <a:ext cx="2850244" cy="1916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8"/>
          </a:graphicData>
        </a:graphic>
      </p:graphicFrame>
      <p:sp>
        <p:nvSpPr>
          <p:cNvPr id="31" name="TextBox 30">
            <a:extLst>
              <a:ext uri="{FF2B5EF4-FFF2-40B4-BE49-F238E27FC236}">
                <a16:creationId xmlns:a16="http://schemas.microsoft.com/office/drawing/2014/main" id="{43BDAE6F-07FA-6710-8E98-2EC452461E7D}"/>
              </a:ext>
            </a:extLst>
          </p:cNvPr>
          <p:cNvSpPr txBox="1"/>
          <p:nvPr/>
        </p:nvSpPr>
        <p:spPr>
          <a:xfrm>
            <a:off x="5926715" y="4904218"/>
            <a:ext cx="2286203" cy="2308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ignal= Average score of h</a:t>
            </a:r>
            <a:r>
              <a:rPr kumimoji="0" lang="en-US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ghest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10% tumors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2AA49AF-34DD-4800-638F-BB5DAA8BC2B7}"/>
              </a:ext>
            </a:extLst>
          </p:cNvPr>
          <p:cNvSpPr txBox="1"/>
          <p:nvPr/>
        </p:nvSpPr>
        <p:spPr>
          <a:xfrm>
            <a:off x="8321816" y="4892341"/>
            <a:ext cx="2239716" cy="2308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oise= Average score of l</a:t>
            </a:r>
            <a:r>
              <a:rPr kumimoji="0" lang="en-US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owest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10% tumors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F121968-9828-6FF0-2E28-BDADAAFEEE57}"/>
              </a:ext>
            </a:extLst>
          </p:cNvPr>
          <p:cNvSpPr txBox="1"/>
          <p:nvPr/>
        </p:nvSpPr>
        <p:spPr>
          <a:xfrm>
            <a:off x="5910684" y="2555425"/>
            <a:ext cx="2257349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ignal= Average score of positive cell line controls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24E9AA6-189F-501D-58E5-331DC5720E8E}"/>
              </a:ext>
            </a:extLst>
          </p:cNvPr>
          <p:cNvSpPr txBox="1"/>
          <p:nvPr/>
        </p:nvSpPr>
        <p:spPr>
          <a:xfrm>
            <a:off x="8321816" y="2570432"/>
            <a:ext cx="2276585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oise= Average score of negative cell line controls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7747E11-DAD6-0E96-58C7-3C59D78303D1}"/>
              </a:ext>
            </a:extLst>
          </p:cNvPr>
          <p:cNvSpPr txBox="1"/>
          <p:nvPr/>
        </p:nvSpPr>
        <p:spPr>
          <a:xfrm rot="16200000">
            <a:off x="-1035248" y="4988362"/>
            <a:ext cx="2387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Negative</a:t>
            </a:r>
            <a:r>
              <a:rPr lang="en-US" sz="1200" b="1" dirty="0"/>
              <a:t> cell line control-JURKAT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99818C5-CF16-A831-510F-0D6CE92F4322}"/>
              </a:ext>
            </a:extLst>
          </p:cNvPr>
          <p:cNvSpPr txBox="1"/>
          <p:nvPr/>
        </p:nvSpPr>
        <p:spPr>
          <a:xfrm rot="16200000">
            <a:off x="-1077985" y="1759862"/>
            <a:ext cx="24799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ositive cell line control-BEWO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3C6B470-41EF-446D-5180-5B0887A5872C}"/>
              </a:ext>
            </a:extLst>
          </p:cNvPr>
          <p:cNvSpPr txBox="1"/>
          <p:nvPr/>
        </p:nvSpPr>
        <p:spPr>
          <a:xfrm>
            <a:off x="4399816" y="283568"/>
            <a:ext cx="12560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CAM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B05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K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chemeClr val="accent1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API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B6E39608-7B58-829C-132D-C7422BD062B5}"/>
              </a:ext>
            </a:extLst>
          </p:cNvPr>
          <p:cNvSpPr txBox="1"/>
          <p:nvPr/>
        </p:nvSpPr>
        <p:spPr>
          <a:xfrm>
            <a:off x="5863882" y="5278582"/>
            <a:ext cx="6189574" cy="107170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tabLst>
                <a:tab pos="2054860" algn="l"/>
              </a:tabLst>
            </a:pPr>
            <a:r>
              <a:rPr lang="en-US" sz="1200" b="1" dirty="0">
                <a:effectLst/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. Antibody Validation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Representative Images of staining pattern for four different monoclonal BCAM antibodies- AB111181(Abcam) at 1ug/ml; FQ5276(Creative Diagnostics) at 1ug/ml; MCA1982(</a:t>
            </a:r>
            <a:r>
              <a:rPr lang="en-US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iorad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at 10ug/ml; MM0107(Novus Biological) at 15ug/ml in (a) positive cell line control (BEWO) and (b) Negative cell line control (JURKAT). Signal to noise peak for these antibodies in tumors on YTMA 558 (c). </a:t>
            </a:r>
          </a:p>
        </p:txBody>
      </p:sp>
    </p:spTree>
    <p:extLst>
      <p:ext uri="{BB962C8B-B14F-4D97-AF65-F5344CB8AC3E}">
        <p14:creationId xmlns:p14="http://schemas.microsoft.com/office/powerpoint/2010/main" val="13172536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DC6D4F62-4E6F-3FC1-64A9-E902D4F64C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7238" y="110848"/>
            <a:ext cx="9829127" cy="338502"/>
          </a:xfrm>
        </p:spPr>
        <p:txBody>
          <a:bodyPr>
            <a:normAutofit fontScale="90000"/>
          </a:bodyPr>
          <a:lstStyle/>
          <a:p>
            <a:r>
              <a:rPr lang="en-US" sz="2400" dirty="0"/>
              <a:t>Fig S2. Survival-Kaplan-Meier Curves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E1821644-FE9E-AA9A-D3AF-A1FDB1D3B4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36502309"/>
              </p:ext>
            </p:extLst>
          </p:nvPr>
        </p:nvGraphicFramePr>
        <p:xfrm>
          <a:off x="48077" y="537423"/>
          <a:ext cx="2394018" cy="181503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3864976" imgH="2927332" progId="Prism9.Document">
                  <p:embed/>
                </p:oleObj>
              </mc:Choice>
              <mc:Fallback>
                <p:oleObj name="Prism 9" r:id="rId3" imgW="3864976" imgH="2927332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0AB2716C-DD21-2F51-0073-40FD8E8152A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8077" y="537423"/>
                        <a:ext cx="2394018" cy="1815031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B91609C6-410D-A6F6-27A0-9A5383A79C4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68807900"/>
              </p:ext>
            </p:extLst>
          </p:nvPr>
        </p:nvGraphicFramePr>
        <p:xfrm>
          <a:off x="48077" y="2439076"/>
          <a:ext cx="2394019" cy="18150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4121033" imgH="2927332" progId="Prism9.Document">
                  <p:embed/>
                </p:oleObj>
              </mc:Choice>
              <mc:Fallback>
                <p:oleObj name="Prism 9" r:id="rId5" imgW="4121033" imgH="2927332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061D1D98-392D-4F68-913B-C3B403358C9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8077" y="2439076"/>
                        <a:ext cx="2394019" cy="1815032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0CF7FEDB-F127-1BBE-5918-3E1DB533F01C}"/>
              </a:ext>
            </a:extLst>
          </p:cNvPr>
          <p:cNvSpPr txBox="1"/>
          <p:nvPr/>
        </p:nvSpPr>
        <p:spPr>
          <a:xfrm>
            <a:off x="511177" y="4283308"/>
            <a:ext cx="13084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A. Ovarian Carcinom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B515348-9082-B4C2-88F0-79D81B05A222}"/>
              </a:ext>
            </a:extLst>
          </p:cNvPr>
          <p:cNvSpPr txBox="1"/>
          <p:nvPr/>
        </p:nvSpPr>
        <p:spPr>
          <a:xfrm>
            <a:off x="3094886" y="4283309"/>
            <a:ext cx="11499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B. Lung Carcinom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EFDF1B2-EDEC-670C-09E2-1820DFDA0565}"/>
              </a:ext>
            </a:extLst>
          </p:cNvPr>
          <p:cNvSpPr txBox="1"/>
          <p:nvPr/>
        </p:nvSpPr>
        <p:spPr>
          <a:xfrm>
            <a:off x="7392107" y="4283308"/>
            <a:ext cx="227998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D. Head &amp; Neck Squamous cell Carcinom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0BB0CBA-CADF-C954-7B57-DF4A96573398}"/>
              </a:ext>
            </a:extLst>
          </p:cNvPr>
          <p:cNvSpPr txBox="1"/>
          <p:nvPr/>
        </p:nvSpPr>
        <p:spPr>
          <a:xfrm>
            <a:off x="10564332" y="4283308"/>
            <a:ext cx="1295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E. Bladder Carcinoma</a:t>
            </a:r>
          </a:p>
        </p:txBody>
      </p: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54861F18-8712-C9E4-5051-221B3396263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97387607"/>
              </p:ext>
            </p:extLst>
          </p:nvPr>
        </p:nvGraphicFramePr>
        <p:xfrm>
          <a:off x="7326104" y="537422"/>
          <a:ext cx="2407569" cy="18150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4340356" imgH="2918328" progId="Prism9.Document">
                  <p:embed/>
                </p:oleObj>
              </mc:Choice>
              <mc:Fallback>
                <p:oleObj name="Prism 9" r:id="rId7" imgW="4340356" imgH="2918328" progId="Prism9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98CBBE2E-6438-E8E6-A67B-D05DACAC399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326104" y="537422"/>
                        <a:ext cx="2407569" cy="1815032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A26D3239-CFB7-D4A7-E703-E4AAB2544B4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42012714"/>
              </p:ext>
            </p:extLst>
          </p:nvPr>
        </p:nvGraphicFramePr>
        <p:xfrm>
          <a:off x="7336518" y="2439076"/>
          <a:ext cx="2407570" cy="18253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9" imgW="4030999" imgH="2918328" progId="Prism9.Document">
                  <p:embed/>
                </p:oleObj>
              </mc:Choice>
              <mc:Fallback>
                <p:oleObj name="Prism 9" r:id="rId9" imgW="4030999" imgH="2918328" progId="Prism9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FEA0C4C8-6349-D73B-88E1-B3C8C88A6FF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7336518" y="2439076"/>
                        <a:ext cx="2407570" cy="1825307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8998BA2C-1B62-2BD1-0242-7D9A74BFAEB8}"/>
              </a:ext>
            </a:extLst>
          </p:cNvPr>
          <p:cNvSpPr txBox="1"/>
          <p:nvPr/>
        </p:nvSpPr>
        <p:spPr>
          <a:xfrm>
            <a:off x="5391403" y="4310899"/>
            <a:ext cx="12316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C. Breast Carcinoma</a:t>
            </a:r>
          </a:p>
        </p:txBody>
      </p:sp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C6F0DC42-757C-15D1-ACED-40C452E422D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78666081"/>
              </p:ext>
            </p:extLst>
          </p:nvPr>
        </p:nvGraphicFramePr>
        <p:xfrm>
          <a:off x="4895937" y="537422"/>
          <a:ext cx="2400127" cy="18150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1" imgW="5108885" imgH="2863225" progId="Prism9.Document">
                  <p:embed/>
                </p:oleObj>
              </mc:Choice>
              <mc:Fallback>
                <p:oleObj name="Prism 9" r:id="rId11" imgW="5108885" imgH="2863225" progId="Prism9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342624F9-72F9-DA78-BA1C-7A5DA972AD0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895937" y="537422"/>
                        <a:ext cx="2400127" cy="1815032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1008A988-C3FB-6D71-6646-B5707D26158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5459490"/>
              </p:ext>
            </p:extLst>
          </p:nvPr>
        </p:nvGraphicFramePr>
        <p:xfrm>
          <a:off x="4910843" y="2439076"/>
          <a:ext cx="2370314" cy="18249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3" imgW="4944303" imgH="2918328" progId="Prism9.Document">
                  <p:embed/>
                </p:oleObj>
              </mc:Choice>
              <mc:Fallback>
                <p:oleObj name="Prism 9" r:id="rId13" imgW="4944303" imgH="2918328" progId="Prism9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E3E0316A-13E2-9346-CE95-502A5FEFFEA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910843" y="2439076"/>
                        <a:ext cx="2370314" cy="1824983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B2083A0F-D58B-122A-2964-E2BFB8A959B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73646"/>
              </p:ext>
            </p:extLst>
          </p:nvPr>
        </p:nvGraphicFramePr>
        <p:xfrm>
          <a:off x="9811348" y="2439076"/>
          <a:ext cx="2391200" cy="18249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5" imgW="3828243" imgH="2918328" progId="Prism9.Document">
                  <p:embed/>
                </p:oleObj>
              </mc:Choice>
              <mc:Fallback>
                <p:oleObj name="Prism 9" r:id="rId15" imgW="3828243" imgH="2918328" progId="Prism9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9285DEFA-23E4-5F65-151D-14C8C148841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9811348" y="2439076"/>
                        <a:ext cx="2391200" cy="1824983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E72429CA-E0D8-6B29-DB2E-08058AABE46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26604648"/>
              </p:ext>
            </p:extLst>
          </p:nvPr>
        </p:nvGraphicFramePr>
        <p:xfrm>
          <a:off x="9783041" y="537422"/>
          <a:ext cx="2378161" cy="18150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7" imgW="3828243" imgH="2918328" progId="Prism9.Document">
                  <p:embed/>
                </p:oleObj>
              </mc:Choice>
              <mc:Fallback>
                <p:oleObj name="Prism 9" r:id="rId17" imgW="3828243" imgH="2918328" progId="Prism9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1AE8288C-4C53-C96A-E52A-764D717B8DC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9783041" y="537422"/>
                        <a:ext cx="2378161" cy="1815032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853ADCD3-B24E-5976-DA23-2ABE4376FE8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9793327"/>
              </p:ext>
            </p:extLst>
          </p:nvPr>
        </p:nvGraphicFramePr>
        <p:xfrm>
          <a:off x="2466398" y="537423"/>
          <a:ext cx="2405236" cy="181503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9" imgW="4553916" imgH="2844857" progId="Prism9.Document">
                  <p:embed/>
                </p:oleObj>
              </mc:Choice>
              <mc:Fallback>
                <p:oleObj name="Prism 9" r:id="rId19" imgW="4553916" imgH="2844857" progId="Prism9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3FB10A50-0D41-A1CB-6A5B-7AC6BE7EAA9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2466398" y="537423"/>
                        <a:ext cx="2405236" cy="1815031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>
            <a:extLst>
              <a:ext uri="{FF2B5EF4-FFF2-40B4-BE49-F238E27FC236}">
                <a16:creationId xmlns:a16="http://schemas.microsoft.com/office/drawing/2014/main" id="{60103422-7A01-1F43-37DE-2644759ED4B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63452011"/>
              </p:ext>
            </p:extLst>
          </p:nvPr>
        </p:nvGraphicFramePr>
        <p:xfrm>
          <a:off x="2466399" y="2440526"/>
          <a:ext cx="2370314" cy="181358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1" imgW="4646831" imgH="2918328" progId="Prism9.Document">
                  <p:embed/>
                </p:oleObj>
              </mc:Choice>
              <mc:Fallback>
                <p:oleObj name="Prism 9" r:id="rId21" imgW="4646831" imgH="2918328" progId="Prism9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4BD3DEF7-86DF-D91E-0A3B-35E8FDBDEF5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2466399" y="2440526"/>
                        <a:ext cx="2370314" cy="1813582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Table 19">
            <a:extLst>
              <a:ext uri="{FF2B5EF4-FFF2-40B4-BE49-F238E27FC236}">
                <a16:creationId xmlns:a16="http://schemas.microsoft.com/office/drawing/2014/main" id="{A63412B4-A23B-CF8C-80F5-2684FBA5F08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27236115"/>
              </p:ext>
            </p:extLst>
          </p:nvPr>
        </p:nvGraphicFramePr>
        <p:xfrm>
          <a:off x="619548" y="4674380"/>
          <a:ext cx="5387668" cy="207264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966368">
                  <a:extLst>
                    <a:ext uri="{9D8B030D-6E8A-4147-A177-3AD203B41FA5}">
                      <a16:colId xmlns:a16="http://schemas.microsoft.com/office/drawing/2014/main" val="2291956291"/>
                    </a:ext>
                  </a:extLst>
                </a:gridCol>
                <a:gridCol w="1085738">
                  <a:extLst>
                    <a:ext uri="{9D8B030D-6E8A-4147-A177-3AD203B41FA5}">
                      <a16:colId xmlns:a16="http://schemas.microsoft.com/office/drawing/2014/main" val="3078688530"/>
                    </a:ext>
                  </a:extLst>
                </a:gridCol>
                <a:gridCol w="1167781">
                  <a:extLst>
                    <a:ext uri="{9D8B030D-6E8A-4147-A177-3AD203B41FA5}">
                      <a16:colId xmlns:a16="http://schemas.microsoft.com/office/drawing/2014/main" val="1706859711"/>
                    </a:ext>
                  </a:extLst>
                </a:gridCol>
                <a:gridCol w="1167781">
                  <a:extLst>
                    <a:ext uri="{9D8B030D-6E8A-4147-A177-3AD203B41FA5}">
                      <a16:colId xmlns:a16="http://schemas.microsoft.com/office/drawing/2014/main" val="3869515621"/>
                    </a:ext>
                  </a:extLst>
                </a:gridCol>
              </a:tblGrid>
              <a:tr h="242426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Type of tumor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effectLst/>
                        </a:rPr>
                        <a:t>Cut Point</a:t>
                      </a:r>
                      <a:endParaRPr lang="en-US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Uncorrected P value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Hazard Ratio(High/Low)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729848532"/>
                  </a:ext>
                </a:extLst>
              </a:tr>
              <a:tr h="131634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Ovarian Carcinoma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Median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0.3911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1.17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860043627"/>
                  </a:ext>
                </a:extLst>
              </a:tr>
              <a:tr h="13821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Visual Threshold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0.7267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1.078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097601424"/>
                  </a:ext>
                </a:extLst>
              </a:tr>
              <a:tr h="131634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Lung Carcinoma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Median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0.0097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0.5885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035299571"/>
                  </a:ext>
                </a:extLst>
              </a:tr>
              <a:tr h="13821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Visual Threshold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0.0029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0.5883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36946722"/>
                  </a:ext>
                </a:extLst>
              </a:tr>
              <a:tr h="131634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Breast Carcinoma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Median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0.5714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0.811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762725445"/>
                  </a:ext>
                </a:extLst>
              </a:tr>
              <a:tr h="13821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Visual Threshold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0.1575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0.7093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59778536"/>
                  </a:ext>
                </a:extLst>
              </a:tr>
              <a:tr h="131634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Head and neck Squamous cell Carcinoma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Median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0.3791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1.154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900191609"/>
                  </a:ext>
                </a:extLst>
              </a:tr>
              <a:tr h="13821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Visual Threshold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0.5091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1.128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739439859"/>
                  </a:ext>
                </a:extLst>
              </a:tr>
              <a:tr h="131634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Bladder Carcinoma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Median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0.2155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0.7948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403647463"/>
                  </a:ext>
                </a:extLst>
              </a:tr>
              <a:tr h="13821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Visual Threshold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0.8914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effectLst/>
                        </a:rPr>
                        <a:t>0.9707</a:t>
                      </a:r>
                      <a:endParaRPr lang="en-US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70210760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942486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295</Words>
  <Application>Microsoft Macintosh PowerPoint</Application>
  <PresentationFormat>Widescreen</PresentationFormat>
  <Paragraphs>78</Paragraphs>
  <Slides>3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rism 9</vt:lpstr>
      <vt:lpstr>Supplementary figures</vt:lpstr>
      <vt:lpstr>Fig  S1. Antibody Validation</vt:lpstr>
      <vt:lpstr>Fig S2. Survival-Kaplan-Meier Curv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Burela, Sneha</dc:creator>
  <cp:lastModifiedBy>Burela, Sneha</cp:lastModifiedBy>
  <cp:revision>1</cp:revision>
  <dcterms:created xsi:type="dcterms:W3CDTF">2023-09-21T19:49:24Z</dcterms:created>
  <dcterms:modified xsi:type="dcterms:W3CDTF">2023-09-21T20:05:52Z</dcterms:modified>
</cp:coreProperties>
</file>